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1" autoAdjust="0"/>
    <p:restoredTop sz="94660"/>
  </p:normalViewPr>
  <p:slideViewPr>
    <p:cSldViewPr snapToGrid="0">
      <p:cViewPr varScale="1">
        <p:scale>
          <a:sx n="44" d="100"/>
          <a:sy n="44" d="100"/>
        </p:scale>
        <p:origin x="64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7939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7632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5742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35083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5541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183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025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7940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871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8698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528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1BC494-E59E-40E3-A798-137E14DE9DD6}" type="datetimeFigureOut">
              <a:rPr kumimoji="1" lang="ja-JP" altLang="en-US" smtClean="0"/>
              <a:t>2024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9837B6-D725-4792-82E4-86A283A5B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9960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80" t="11297" b="7585"/>
          <a:stretch/>
        </p:blipFill>
        <p:spPr bwMode="auto">
          <a:xfrm>
            <a:off x="2880359" y="1207009"/>
            <a:ext cx="5421057" cy="37216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正方形/長方形 3"/>
          <p:cNvSpPr/>
          <p:nvPr/>
        </p:nvSpPr>
        <p:spPr>
          <a:xfrm>
            <a:off x="3673437" y="837677"/>
            <a:ext cx="40587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dirty="0" smtClean="0"/>
              <a:t>Age normality Q-Q plot for Healthy group</a:t>
            </a:r>
            <a:endParaRPr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564999" y="1728216"/>
            <a:ext cx="461665" cy="254178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ja-JP" dirty="0"/>
              <a:t>expectation normalization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786756" y="4910330"/>
            <a:ext cx="1608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observed value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090887" y="5196683"/>
            <a:ext cx="5210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ignificance probability by Shapiro-Wilk </a:t>
            </a:r>
            <a:r>
              <a:rPr lang="en-US" altLang="ja-JP" dirty="0" smtClean="0"/>
              <a:t>test</a:t>
            </a:r>
            <a:r>
              <a:rPr lang="ja-JP" altLang="en-US" dirty="0" smtClean="0"/>
              <a:t>　</a:t>
            </a:r>
            <a:r>
              <a:rPr lang="en-US" altLang="ja-JP" dirty="0" smtClean="0"/>
              <a:t>p=0.447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907986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3673438" y="757166"/>
            <a:ext cx="37151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dirty="0" smtClean="0"/>
              <a:t>Age normality Q-Q plot for </a:t>
            </a:r>
            <a:r>
              <a:rPr lang="en-US" altLang="ja-JP" dirty="0" smtClean="0"/>
              <a:t>MCI</a:t>
            </a:r>
            <a:r>
              <a:rPr lang="ja-JP" altLang="en-US" dirty="0" smtClean="0"/>
              <a:t> group</a:t>
            </a:r>
            <a:endParaRPr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482703" y="1709928"/>
            <a:ext cx="461665" cy="254178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ja-JP" dirty="0"/>
              <a:t>expectation normalization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848932" y="4743951"/>
            <a:ext cx="1608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observed value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047799" y="5113283"/>
            <a:ext cx="5210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ignificance probability by Shapiro-Wilk </a:t>
            </a:r>
            <a:r>
              <a:rPr lang="en-US" altLang="ja-JP" dirty="0" smtClean="0"/>
              <a:t>test</a:t>
            </a:r>
            <a:r>
              <a:rPr lang="ja-JP" altLang="en-US" dirty="0" smtClean="0"/>
              <a:t>　</a:t>
            </a:r>
            <a:r>
              <a:rPr lang="en-US" altLang="ja-JP" dirty="0" smtClean="0"/>
              <a:t>p&lt;0.001</a:t>
            </a:r>
            <a:endParaRPr kumimoji="1" lang="ja-JP" altLang="en-US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85" t="11733" r="-690" b="6985"/>
          <a:stretch/>
        </p:blipFill>
        <p:spPr bwMode="auto">
          <a:xfrm>
            <a:off x="2803732" y="1162976"/>
            <a:ext cx="5454596" cy="3729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1415569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3673438" y="757166"/>
            <a:ext cx="42548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dirty="0" smtClean="0"/>
              <a:t>Age normality Q-Q plot for </a:t>
            </a:r>
            <a:r>
              <a:rPr lang="en-US" altLang="ja-JP" dirty="0" smtClean="0"/>
              <a:t>Dementia </a:t>
            </a:r>
            <a:r>
              <a:rPr lang="ja-JP" altLang="en-US" dirty="0" smtClean="0"/>
              <a:t>group</a:t>
            </a:r>
            <a:endParaRPr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635878" y="1618488"/>
            <a:ext cx="461665" cy="254178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ja-JP" dirty="0"/>
              <a:t>expectation normalization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996748" y="4812190"/>
            <a:ext cx="1608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observed value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185702" y="5077811"/>
            <a:ext cx="5210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ignificance probability by Shapiro-Wilk </a:t>
            </a:r>
            <a:r>
              <a:rPr lang="en-US" altLang="ja-JP" dirty="0" smtClean="0"/>
              <a:t>test</a:t>
            </a:r>
            <a:r>
              <a:rPr lang="ja-JP" altLang="en-US" dirty="0" smtClean="0"/>
              <a:t>　</a:t>
            </a:r>
            <a:r>
              <a:rPr lang="en-US" altLang="ja-JP" dirty="0" smtClean="0"/>
              <a:t>p&lt;0.071</a:t>
            </a:r>
            <a:endParaRPr kumimoji="1" lang="ja-JP" alt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7" t="11245" b="6242"/>
          <a:stretch/>
        </p:blipFill>
        <p:spPr bwMode="auto">
          <a:xfrm>
            <a:off x="3009383" y="1143001"/>
            <a:ext cx="5386848" cy="37856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833459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4</Words>
  <Application>Microsoft Office PowerPoint</Application>
  <PresentationFormat>ワイド画面</PresentationFormat>
  <Paragraphs>12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>l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原　裕一</dc:creator>
  <cp:lastModifiedBy>石原　裕一</cp:lastModifiedBy>
  <cp:revision>3</cp:revision>
  <dcterms:created xsi:type="dcterms:W3CDTF">2024-07-29T23:52:37Z</dcterms:created>
  <dcterms:modified xsi:type="dcterms:W3CDTF">2024-08-19T06:41:14Z</dcterms:modified>
</cp:coreProperties>
</file>